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5143500" type="screen16x9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8" d="100"/>
          <a:sy n="98" d="100"/>
        </p:scale>
        <p:origin x="-408" y="-68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2" y="1597820"/>
            <a:ext cx="7772400" cy="110252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1" y="205980"/>
            <a:ext cx="2057401" cy="438864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2" y="205980"/>
            <a:ext cx="6019801" cy="438864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4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4" y="2180038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4" y="1200154"/>
            <a:ext cx="4038601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4" y="1200154"/>
            <a:ext cx="4038601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2" y="1151338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2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31" y="1151338"/>
            <a:ext cx="4041774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31" y="1631156"/>
            <a:ext cx="4041774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4" y="204790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4" y="204791"/>
            <a:ext cx="5111749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4" y="1076328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3600451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4025505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200154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5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2" y="4767263"/>
            <a:ext cx="2895600" cy="273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26263" y="4121260"/>
            <a:ext cx="8866853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PRRSV isolations from representative clinical samples.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ree qPCR and PMA-qPCR positive samples and three qPCR positive but PMA-qPCR negative samples (100 </a:t>
            </a:r>
            <a:r>
              <a:rPr lang="el-GR" altLang="zh-CN" sz="1000" dirty="0" smtClean="0">
                <a:latin typeface="Times New Roman"/>
                <a:cs typeface="Times New Roman"/>
              </a:rPr>
              <a:t>μ</a:t>
            </a:r>
            <a:r>
              <a:rPr lang="en-US" altLang="zh-CN" sz="1000" dirty="0" smtClean="0">
                <a:latin typeface="Times New Roman"/>
                <a:cs typeface="Times New Roman"/>
              </a:rPr>
              <a:t>l filtered supernatant from each sample homogenate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re selected and used for virus isolation in PAMs. IFA detection was performed at 72 </a:t>
            </a:r>
            <a:r>
              <a:rPr lang="en-US" altLang="zh-CN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RRSV N protein specific signals could only be detected in three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PCR and PMA-qPCR positive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s. Anheal-1 infection (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 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I) was set as positive control and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MI-1640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s added to negative control.</a:t>
            </a:r>
            <a:endParaRPr lang="zh-CN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263" y="411510"/>
            <a:ext cx="8812874" cy="363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66306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89</Words>
  <Application>Microsoft Office PowerPoint</Application>
  <PresentationFormat>全屏显示(16:9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anhua Chen</dc:creator>
  <cp:lastModifiedBy>Nanhua Chen</cp:lastModifiedBy>
  <cp:revision>18</cp:revision>
  <dcterms:created xsi:type="dcterms:W3CDTF">2024-10-09T06:38:59Z</dcterms:created>
  <dcterms:modified xsi:type="dcterms:W3CDTF">2025-07-04T02:57:27Z</dcterms:modified>
</cp:coreProperties>
</file>